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4C5A5CE-0B45-C944-B7C5-0D8C9102D48D}" v="1" dt="2020-09-24T21:32:13.02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530"/>
    <p:restoredTop sz="96327"/>
  </p:normalViewPr>
  <p:slideViewPr>
    <p:cSldViewPr snapToGrid="0" snapToObjects="1" showGuides="1">
      <p:cViewPr varScale="1">
        <p:scale>
          <a:sx n="124" d="100"/>
          <a:sy n="124" d="100"/>
        </p:scale>
        <p:origin x="288" y="1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APTIEUX Rae" userId="3a961199-96dc-4b2e-8ea9-3b6407fb953a" providerId="ADAL" clId="{034BD82C-31F4-004F-89F1-E4FD4A9F7B2E}"/>
    <pc:docChg chg="addSld delSld modSld">
      <pc:chgData name="CAPTIEUX Rae" userId="3a961199-96dc-4b2e-8ea9-3b6407fb953a" providerId="ADAL" clId="{034BD82C-31F4-004F-89F1-E4FD4A9F7B2E}" dt="2020-09-01T19:38:54.646" v="1" actId="2696"/>
      <pc:docMkLst>
        <pc:docMk/>
      </pc:docMkLst>
      <pc:sldChg chg="del">
        <pc:chgData name="CAPTIEUX Rae" userId="3a961199-96dc-4b2e-8ea9-3b6407fb953a" providerId="ADAL" clId="{034BD82C-31F4-004F-89F1-E4FD4A9F7B2E}" dt="2020-09-01T19:38:54.646" v="1" actId="2696"/>
        <pc:sldMkLst>
          <pc:docMk/>
          <pc:sldMk cId="416151509" sldId="263"/>
        </pc:sldMkLst>
      </pc:sldChg>
      <pc:sldChg chg="add">
        <pc:chgData name="CAPTIEUX Rae" userId="3a961199-96dc-4b2e-8ea9-3b6407fb953a" providerId="ADAL" clId="{034BD82C-31F4-004F-89F1-E4FD4A9F7B2E}" dt="2020-09-01T19:38:52.550" v="0"/>
        <pc:sldMkLst>
          <pc:docMk/>
          <pc:sldMk cId="2361739135" sldId="268"/>
        </pc:sldMkLst>
      </pc:sldChg>
    </pc:docChg>
  </pc:docChgLst>
  <pc:docChgLst>
    <pc:chgData name="CAPTIEUX Rae" userId="3a961199-96dc-4b2e-8ea9-3b6407fb953a" providerId="ADAL" clId="{64C5A5CE-0B45-C944-B7C5-0D8C9102D48D}"/>
    <pc:docChg chg="modSld">
      <pc:chgData name="CAPTIEUX Rae" userId="3a961199-96dc-4b2e-8ea9-3b6407fb953a" providerId="ADAL" clId="{64C5A5CE-0B45-C944-B7C5-0D8C9102D48D}" dt="2020-09-24T21:32:15.789" v="2" actId="20577"/>
      <pc:docMkLst>
        <pc:docMk/>
      </pc:docMkLst>
      <pc:sldChg chg="modSp mod">
        <pc:chgData name="CAPTIEUX Rae" userId="3a961199-96dc-4b2e-8ea9-3b6407fb953a" providerId="ADAL" clId="{64C5A5CE-0B45-C944-B7C5-0D8C9102D48D}" dt="2020-09-24T21:32:15.789" v="2" actId="20577"/>
        <pc:sldMkLst>
          <pc:docMk/>
          <pc:sldMk cId="2361739135" sldId="268"/>
        </pc:sldMkLst>
        <pc:spChg chg="mod">
          <ac:chgData name="CAPTIEUX Rae" userId="3a961199-96dc-4b2e-8ea9-3b6407fb953a" providerId="ADAL" clId="{64C5A5CE-0B45-C944-B7C5-0D8C9102D48D}" dt="2020-09-24T21:32:15.789" v="2" actId="20577"/>
          <ac:spMkLst>
            <pc:docMk/>
            <pc:sldMk cId="2361739135" sldId="268"/>
            <ac:spMk id="3" creationId="{2FDC7682-95A9-054B-8A5B-71D8D1CD48A1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F1FCC1-6EE6-684D-9952-4592ABBC2FE9}" type="datetimeFigureOut">
              <a:rPr lang="en-US" smtClean="0"/>
              <a:t>9/24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14F5421-11C0-BE45-B08D-FC3C1ED8B1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24871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/>
              <a:t>P [21] Drug element present</a:t>
            </a:r>
          </a:p>
          <a:p>
            <a:endParaRPr lang="en-GB"/>
          </a:p>
          <a:p>
            <a:r>
              <a:rPr lang="en-GB"/>
              <a:t>Drug element present [6] "AT5 years"</a:t>
            </a:r>
          </a:p>
          <a:p>
            <a:r>
              <a:rPr lang="en-GB"/>
              <a:t> "AT5 years" [2] HB&lt;48,FPG&lt;7</a:t>
            </a:r>
          </a:p>
          <a:p>
            <a:r>
              <a:rPr lang="en-GB"/>
              <a:t> "AT5 years" [2] HB&lt;48&amp;FPG&lt;7</a:t>
            </a:r>
          </a:p>
          <a:p>
            <a:r>
              <a:rPr lang="en-GB"/>
              <a:t>  "AT5 years" [2] HB&lt;42&amp;FPG&lt;5.6</a:t>
            </a:r>
          </a:p>
          <a:p>
            <a:endParaRPr lang="en-GB"/>
          </a:p>
          <a:p>
            <a:r>
              <a:rPr lang="en-GB"/>
              <a:t>:Drug element present  #5D6D7E</a:t>
            </a:r>
          </a:p>
          <a:p>
            <a:r>
              <a:rPr lang="en-GB"/>
              <a:t>:"AT5 years" #5D6D7E</a:t>
            </a:r>
          </a:p>
          <a:p>
            <a:r>
              <a:rPr lang="en-GB"/>
              <a:t>:HB&lt;48&amp;FPG&lt;7 #5D6D7E</a:t>
            </a:r>
          </a:p>
          <a:p>
            <a:r>
              <a:rPr lang="en-GB"/>
              <a:t>:HB&lt;48,FPG&lt;7 #5D6D7E</a:t>
            </a:r>
          </a:p>
          <a:p>
            <a:r>
              <a:rPr lang="en-GB"/>
              <a:t>:HB&lt;42&amp;FPG&lt;5.6 #5D6D7E</a:t>
            </a:r>
          </a:p>
          <a:p>
            <a:endParaRPr lang="en-GB"/>
          </a:p>
          <a:p>
            <a:endParaRPr lang="en-GB"/>
          </a:p>
          <a:p>
            <a:r>
              <a:rPr lang="en-GB"/>
              <a:t>Drug element present [15] "For 5 year"</a:t>
            </a:r>
          </a:p>
          <a:p>
            <a:endParaRPr lang="en-GB"/>
          </a:p>
          <a:p>
            <a:r>
              <a:rPr lang="en-GB"/>
              <a:t> "For 5 year" [1]FPG&lt;5.6/100</a:t>
            </a:r>
          </a:p>
          <a:p>
            <a:r>
              <a:rPr lang="en-GB"/>
              <a:t> "For 5 year" [1]HB&lt;48,FPG&lt;7</a:t>
            </a:r>
          </a:p>
          <a:p>
            <a:r>
              <a:rPr lang="en-GB"/>
              <a:t> "For 5 year" [1]HB&lt;48,FPG&lt;5.6</a:t>
            </a:r>
          </a:p>
          <a:p>
            <a:r>
              <a:rPr lang="en-GB"/>
              <a:t> "For 5 year" [1]HB&lt;48&amp;FPG&lt;5.6</a:t>
            </a:r>
          </a:p>
          <a:p>
            <a:endParaRPr lang="en-GB"/>
          </a:p>
          <a:p>
            <a:endParaRPr lang="en-GB"/>
          </a:p>
          <a:p>
            <a:r>
              <a:rPr lang="en-GB"/>
              <a:t>"For 5 year" [7]HB&lt;42</a:t>
            </a:r>
          </a:p>
          <a:p>
            <a:r>
              <a:rPr lang="en-GB"/>
              <a:t>"For 5 year" [1]HB&lt;42,FPG&lt;5.6</a:t>
            </a:r>
          </a:p>
          <a:p>
            <a:r>
              <a:rPr lang="en-GB"/>
              <a:t>"For 5 year" [2]HB&lt;42&amp;FPG&lt;5.6</a:t>
            </a:r>
          </a:p>
          <a:p>
            <a:endParaRPr lang="en-GB"/>
          </a:p>
          <a:p>
            <a:r>
              <a:rPr lang="en-GB"/>
              <a:t>"For 5 year" [1]HB&lt;39</a:t>
            </a:r>
          </a:p>
          <a:p>
            <a:endParaRPr lang="en-GB"/>
          </a:p>
          <a:p>
            <a:r>
              <a:rPr lang="en-GB"/>
              <a:t>:"For 5 year" #5D6D7E</a:t>
            </a:r>
          </a:p>
          <a:p>
            <a:r>
              <a:rPr lang="en-GB"/>
              <a:t>:FPG&lt;5.6/100 #5D6D7E</a:t>
            </a:r>
          </a:p>
          <a:p>
            <a:r>
              <a:rPr lang="en-GB"/>
              <a:t>:HB&lt;48,FPG&lt;7 #5D6D7E</a:t>
            </a:r>
          </a:p>
          <a:p>
            <a:r>
              <a:rPr lang="en-GB"/>
              <a:t>:HB&lt;48,FPG&lt;5.6 #5D6D7E</a:t>
            </a:r>
          </a:p>
          <a:p>
            <a:r>
              <a:rPr lang="en-GB"/>
              <a:t>:HB&lt;48&amp;FPG&lt;5.6 #5D6D7E</a:t>
            </a:r>
          </a:p>
          <a:p>
            <a:r>
              <a:rPr lang="en-GB"/>
              <a:t>:HB&lt;42 #5D6D7E</a:t>
            </a:r>
          </a:p>
          <a:p>
            <a:r>
              <a:rPr lang="en-GB"/>
              <a:t>:HB&lt;42,FPG&lt;5.6 #5D6D7E</a:t>
            </a:r>
          </a:p>
          <a:p>
            <a:r>
              <a:rPr lang="en-GB"/>
              <a:t>:HB&lt;42&amp;FPG&lt;5.6 #5D6D7E</a:t>
            </a:r>
          </a:p>
          <a:p>
            <a:r>
              <a:rPr lang="en-GB"/>
              <a:t>:HB&lt;39 #5D6D7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27F2FC4-DA11-A149-8DA6-A9037C1576BE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30604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B71EB0-A153-7845-918D-63EE233F411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BAA1199-ECCF-794F-B788-7B118390CED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84017F-2D67-7940-87BB-F3E67B84E9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7AB245-E958-AF4A-8771-36DE472503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1F8159-0DB0-6F46-A540-364E0ED0DA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55416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8F296C-0359-F940-8858-359C4F93CF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7CA3596-925B-3E41-9006-4F113CCC1D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B8D450-72C4-6049-AE21-A5ADE356CA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15A521-501C-E446-BC62-6AC0E2CDFE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8C7F82-B7A0-F34F-9FE3-A1E6332098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83089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E172C73-F359-0840-9EC0-404F3B2D2F5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526BBBC-5D13-B04F-8B0C-82AAF32181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02147A-3DE4-6A47-91CA-1E41350F49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0F8119-AE33-A241-9D92-2B3027A28B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DF7C97-4D99-FB4C-92C6-C0D3C6089F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16283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55A5AC-672F-4642-8662-7285C99D2A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35D8094-4684-2842-A93D-0B212E6D802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7C8053-5441-754A-9C65-CD2AB775DD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2387DD-F2B3-0440-8788-FD56321F9C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4921E4-3639-4947-96B6-0712984A42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42521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728924-E957-994B-8C78-3B0E7048EA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AD109CB-3594-A54E-A34A-76018C888C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D7F986-5A61-8B4D-8D4F-069C81260C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87894D-9405-E545-B2BF-5ABD179AE8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4871DA-9CE5-BB4F-8325-1678BA1F3A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5277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45D345-0204-2F4C-9D88-1C84951427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C9492AF-542A-6A46-9ABC-DB5D53C8739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4E1AC9E-4545-6546-9A8C-7F4CA4EE9F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4401E09-7817-8741-9E8F-C617AA36C9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73BF4BC-5CEF-D64E-9D57-787461016D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7E667AA-8379-4540-91AA-43F6653A44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53929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2B8941-1A83-3A4D-B4A7-9EB1F59B1F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1AF4C62-9D87-5F43-B3C4-0A63819A73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B5E6EBA-77EC-4E45-8681-83804B238FA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5A4F034-819B-5349-895D-CC1B85CFF60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5D84BBF-4DB3-0440-858E-D2D952AE9A1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F639079-22A0-EF4B-B999-21354FCE02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2BA785E-FD98-EA47-91EE-EEFD92375F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8A9AE3C-AF1C-8348-BE73-DC3ED0CB99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42553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89F673-A059-B34A-BA62-D6083790D3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5BBE93A-29D6-C444-81FF-02F1B985CE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4D3209C-2E6F-DE45-98A1-3DB3CF5CE8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3E90635-2AD0-DD48-9560-F25434C144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82394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76EBF65-8D31-4F4E-A328-DFC976FA28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3FECE7E-12B5-8942-AF0B-FB0C254B2B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53E4620-0605-5445-9CE2-036CB067F8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03843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525AF9-5494-0144-9036-47D1A30DF5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7A7A4FA-F0C7-5345-BF47-739BFBF7C6C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DA44600-BCB1-724C-BA94-DB8C56B4A45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F51C26D-61D7-9D43-908E-387E9EA00B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FACD2E3-BC60-0240-881C-B77655981E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FB4D528-ED3C-E342-9B27-BB96E9BFF4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25505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A29AEA-27A5-8245-A8EB-25C9AF0E76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32172F6-7064-5543-8287-D040533EEF7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E0BCB8F-1486-A642-9A64-71C9235907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892C211-46FF-EF4E-A5DF-361DA4C399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749704-3DF3-5C44-AF93-84F7D607F1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7578A23-EB0C-6348-AF5B-CDEF1BE326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89971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7A4CA3D-6954-614C-9CCC-417E897E63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483812A-645A-934C-BFBE-11CCCFF2D7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EFFEDD-3BC2-2047-B528-4DACBE82558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14677F-AA0A-8D4F-8408-BD5CA6904827}" type="datetimeFigureOut">
              <a:rPr lang="en-US" smtClean="0"/>
              <a:t>9/2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DBA127-E216-C540-91A3-F10317F346B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949627-11AC-D044-BD3E-3062F688B2B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20D7D5-A9DC-6644-AD84-0972CB56A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08036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" name="Group 27">
            <a:extLst>
              <a:ext uri="{FF2B5EF4-FFF2-40B4-BE49-F238E27FC236}">
                <a16:creationId xmlns:a16="http://schemas.microsoft.com/office/drawing/2014/main" id="{654E5DFD-EDEC-A946-8DDA-A7719042F35C}"/>
              </a:ext>
            </a:extLst>
          </p:cNvPr>
          <p:cNvGrpSpPr/>
          <p:nvPr/>
        </p:nvGrpSpPr>
        <p:grpSpPr>
          <a:xfrm>
            <a:off x="683249" y="431800"/>
            <a:ext cx="10097384" cy="6311900"/>
            <a:chOff x="1406015" y="33498"/>
            <a:chExt cx="10097384" cy="6883202"/>
          </a:xfrm>
        </p:grpSpPr>
        <p:pic>
          <p:nvPicPr>
            <p:cNvPr id="29" name="Picture 28" descr="A close up of a logo&#10;&#10;Description automatically generated">
              <a:extLst>
                <a:ext uri="{FF2B5EF4-FFF2-40B4-BE49-F238E27FC236}">
                  <a16:creationId xmlns:a16="http://schemas.microsoft.com/office/drawing/2014/main" id="{63F69523-94C2-8640-82F1-1093705FF8E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434942" y="33498"/>
              <a:ext cx="6293026" cy="6293026"/>
            </a:xfrm>
            <a:prstGeom prst="rect">
              <a:avLst/>
            </a:prstGeom>
          </p:spPr>
        </p:pic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7693B412-3F36-654C-ADB3-EA72FC18B2F8}"/>
                </a:ext>
              </a:extLst>
            </p:cNvPr>
            <p:cNvSpPr txBox="1"/>
            <p:nvPr/>
          </p:nvSpPr>
          <p:spPr>
            <a:xfrm>
              <a:off x="8593953" y="6036341"/>
              <a:ext cx="26003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>
                  <a:latin typeface="Times" pitchFamily="2" charset="0"/>
                </a:rPr>
                <a:t>ADA criteria: 1</a:t>
              </a:r>
            </a:p>
          </p:txBody>
        </p:sp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id="{70A744F7-7CD7-BB45-9B3D-AD00B85E8B9C}"/>
                </a:ext>
              </a:extLst>
            </p:cNvPr>
            <p:cNvGrpSpPr/>
            <p:nvPr/>
          </p:nvGrpSpPr>
          <p:grpSpPr>
            <a:xfrm>
              <a:off x="1406015" y="83601"/>
              <a:ext cx="10097384" cy="5923947"/>
              <a:chOff x="393629" y="122555"/>
              <a:chExt cx="11288824" cy="6859861"/>
            </a:xfrm>
          </p:grpSpPr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6DF63EC3-6EE2-3145-B7D8-700EBF2E14E3}"/>
                  </a:ext>
                </a:extLst>
              </p:cNvPr>
              <p:cNvSpPr txBox="1"/>
              <p:nvPr/>
            </p:nvSpPr>
            <p:spPr>
              <a:xfrm>
                <a:off x="393629" y="3253117"/>
                <a:ext cx="1284820" cy="3920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800">
                    <a:latin typeface="Times" pitchFamily="2" charset="0"/>
                  </a:rPr>
                  <a:t>64 Complete Remission definitions</a:t>
                </a: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F9F80053-D85B-AF41-BAD9-1D0893989055}"/>
                  </a:ext>
                </a:extLst>
              </p:cNvPr>
              <p:cNvSpPr txBox="1"/>
              <p:nvPr/>
            </p:nvSpPr>
            <p:spPr>
              <a:xfrm>
                <a:off x="3047985" y="5947514"/>
                <a:ext cx="897624" cy="2494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>
                    <a:latin typeface="Times" pitchFamily="2" charset="0"/>
                  </a:rPr>
                  <a:t>missing: 2</a:t>
                </a: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1124A31B-4E4E-D64B-BDE8-7EDCE825D8C8}"/>
                  </a:ext>
                </a:extLst>
              </p:cNvPr>
              <p:cNvSpPr txBox="1"/>
              <p:nvPr/>
            </p:nvSpPr>
            <p:spPr>
              <a:xfrm>
                <a:off x="5105628" y="2552052"/>
                <a:ext cx="971181" cy="2494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GB" sz="800">
                    <a:latin typeface="Times" pitchFamily="2" charset="0"/>
                  </a:rPr>
                  <a:t>missing: 25</a:t>
                </a: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FB296008-B45E-9A4A-B59B-137DE3B5976D}"/>
                  </a:ext>
                </a:extLst>
              </p:cNvPr>
              <p:cNvSpPr txBox="1"/>
              <p:nvPr/>
            </p:nvSpPr>
            <p:spPr>
              <a:xfrm>
                <a:off x="5099478" y="4122053"/>
                <a:ext cx="995321" cy="2494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GB" sz="800">
                    <a:latin typeface="Times" pitchFamily="2" charset="0"/>
                  </a:rPr>
                  <a:t>at 1 year: 11</a:t>
                </a: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68BBFF7E-44B3-3144-A900-70BEF62C41B6}"/>
                  </a:ext>
                </a:extLst>
              </p:cNvPr>
              <p:cNvSpPr txBox="1"/>
              <p:nvPr/>
            </p:nvSpPr>
            <p:spPr>
              <a:xfrm>
                <a:off x="3548844" y="5301704"/>
                <a:ext cx="2600325" cy="2494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GB" sz="800">
                    <a:latin typeface="Times" pitchFamily="2" charset="0"/>
                  </a:rPr>
                  <a:t>for 1 year: 25</a:t>
                </a:r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1D61893A-3F36-D74A-AC88-E3E131B50AFE}"/>
                  </a:ext>
                </a:extLst>
              </p:cNvPr>
              <p:cNvSpPr txBox="1"/>
              <p:nvPr/>
            </p:nvSpPr>
            <p:spPr>
              <a:xfrm>
                <a:off x="5061750" y="6719965"/>
                <a:ext cx="1098969" cy="2494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GB" sz="800">
                    <a:latin typeface="Times" pitchFamily="2" charset="0"/>
                  </a:rPr>
                  <a:t>for 90 days: 1</a:t>
                </a:r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54E1EE33-4F41-C941-9533-13B55948DCFC}"/>
                  </a:ext>
                </a:extLst>
              </p:cNvPr>
              <p:cNvSpPr txBox="1"/>
              <p:nvPr/>
            </p:nvSpPr>
            <p:spPr>
              <a:xfrm>
                <a:off x="8429896" y="122555"/>
                <a:ext cx="2600325" cy="2494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>
                    <a:latin typeface="Times" pitchFamily="2" charset="0"/>
                  </a:rPr>
                  <a:t>“2009 consensus criteria:” 1</a:t>
                </a:r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5564F07C-A9B4-D744-AA4D-2EC20CC5BE58}"/>
                  </a:ext>
                </a:extLst>
              </p:cNvPr>
              <p:cNvSpPr txBox="1"/>
              <p:nvPr/>
            </p:nvSpPr>
            <p:spPr>
              <a:xfrm>
                <a:off x="8429707" y="1809225"/>
                <a:ext cx="2600325" cy="2494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>
                    <a:latin typeface="Times" pitchFamily="2" charset="0"/>
                  </a:rPr>
                  <a:t>HbA1c&lt;42mmol/mol: 25</a:t>
                </a: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8EE1307A-24C5-E741-8296-EF4C1B009C7A}"/>
                  </a:ext>
                </a:extLst>
              </p:cNvPr>
              <p:cNvSpPr txBox="1"/>
              <p:nvPr/>
            </p:nvSpPr>
            <p:spPr>
              <a:xfrm>
                <a:off x="8471963" y="2950175"/>
                <a:ext cx="2949183" cy="2494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/>
                  <a:t>HbA1c &lt;</a:t>
                </a:r>
                <a:r>
                  <a:rPr lang="en-GB" sz="800">
                    <a:latin typeface="Times" pitchFamily="2" charset="0"/>
                  </a:rPr>
                  <a:t>42mmol</a:t>
                </a:r>
                <a:r>
                  <a:rPr lang="en-GB" sz="800"/>
                  <a:t>/mol &amp; FPG &lt;6.1mmol/l :3</a:t>
                </a:r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F3D0658A-6129-4C42-B5D2-2C3C5264866A}"/>
                  </a:ext>
                </a:extLst>
              </p:cNvPr>
              <p:cNvSpPr txBox="1"/>
              <p:nvPr/>
            </p:nvSpPr>
            <p:spPr>
              <a:xfrm>
                <a:off x="8440215" y="5171609"/>
                <a:ext cx="3136514" cy="2494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>
                    <a:latin typeface="Times" pitchFamily="2" charset="0"/>
                  </a:rPr>
                  <a:t>HbA1c &lt;39mmol/mol &amp; FPG &lt;5.6mmol/l :5</a:t>
                </a:r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FCB17C9A-23AB-9147-883C-31701BA974B8}"/>
                  </a:ext>
                </a:extLst>
              </p:cNvPr>
              <p:cNvSpPr txBox="1"/>
              <p:nvPr/>
            </p:nvSpPr>
            <p:spPr>
              <a:xfrm>
                <a:off x="8419386" y="4243845"/>
                <a:ext cx="3157532" cy="2494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>
                    <a:latin typeface="Times" pitchFamily="2" charset="0"/>
                  </a:rPr>
                  <a:t>HbA1c &lt;42mmol/mol &amp; FPG &lt;5.6mmol/l: 14</a:t>
                </a:r>
              </a:p>
            </p:txBody>
          </p: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D98932F9-4095-8C4B-8216-35F71945F994}"/>
                  </a:ext>
                </a:extLst>
              </p:cNvPr>
              <p:cNvSpPr txBox="1"/>
              <p:nvPr/>
            </p:nvSpPr>
            <p:spPr>
              <a:xfrm>
                <a:off x="8440215" y="6732934"/>
                <a:ext cx="2600325" cy="2494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>
                    <a:latin typeface="Times" pitchFamily="2" charset="0"/>
                  </a:rPr>
                  <a:t> FPG &lt;5.6mmol/l: 1</a:t>
                </a:r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5A2815FD-ABF8-CD4F-97FB-310418D34E84}"/>
                  </a:ext>
                </a:extLst>
              </p:cNvPr>
              <p:cNvSpPr txBox="1"/>
              <p:nvPr/>
            </p:nvSpPr>
            <p:spPr>
              <a:xfrm>
                <a:off x="8429707" y="6417022"/>
                <a:ext cx="3252746" cy="2494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>
                    <a:latin typeface="Times" pitchFamily="2" charset="0"/>
                  </a:rPr>
                  <a:t>HbA1c &lt;48mmol/mol &amp; FPG &lt;5.6mmol/l: 2</a:t>
                </a:r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74C0331E-5214-7A4C-BA5B-AE0C70E9E48F}"/>
                  </a:ext>
                </a:extLst>
              </p:cNvPr>
              <p:cNvSpPr txBox="1"/>
              <p:nvPr/>
            </p:nvSpPr>
            <p:spPr>
              <a:xfrm>
                <a:off x="8431280" y="6035444"/>
                <a:ext cx="2600325" cy="2494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>
                    <a:latin typeface="Times" pitchFamily="2" charset="0"/>
                  </a:rPr>
                  <a:t>HbA1c &lt;39mmol/mol: 3</a:t>
                </a:r>
              </a:p>
            </p:txBody>
          </p:sp>
        </p:grp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57B76649-BCC7-8945-9B50-268B2468E6C0}"/>
                </a:ext>
              </a:extLst>
            </p:cNvPr>
            <p:cNvSpPr txBox="1"/>
            <p:nvPr/>
          </p:nvSpPr>
          <p:spPr>
            <a:xfrm>
              <a:off x="5558747" y="6049553"/>
              <a:ext cx="102839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800">
                  <a:latin typeface="Times" pitchFamily="2" charset="0"/>
                </a:rPr>
                <a:t>for 6 months:1</a:t>
              </a:r>
            </a:p>
          </p:txBody>
        </p: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B6F56837-6314-0E49-90C3-6D193B1790F4}"/>
                </a:ext>
              </a:extLst>
            </p:cNvPr>
            <p:cNvCxnSpPr>
              <a:cxnSpLocks/>
            </p:cNvCxnSpPr>
            <p:nvPr/>
          </p:nvCxnSpPr>
          <p:spPr>
            <a:xfrm>
              <a:off x="2604321" y="5179566"/>
              <a:ext cx="0" cy="1584743"/>
            </a:xfrm>
            <a:prstGeom prst="line">
              <a:avLst/>
            </a:prstGeom>
            <a:ln>
              <a:solidFill>
                <a:schemeClr val="tx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30E385B8-924A-5E41-9D4D-818CE16BD807}"/>
                </a:ext>
              </a:extLst>
            </p:cNvPr>
            <p:cNvCxnSpPr>
              <a:cxnSpLocks/>
            </p:cNvCxnSpPr>
            <p:nvPr/>
          </p:nvCxnSpPr>
          <p:spPr>
            <a:xfrm>
              <a:off x="4583113" y="5557875"/>
              <a:ext cx="0" cy="1358825"/>
            </a:xfrm>
            <a:prstGeom prst="line">
              <a:avLst/>
            </a:prstGeom>
            <a:ln>
              <a:solidFill>
                <a:schemeClr val="tx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4B9E67C3-7A2F-9043-B7A1-AF142B1BC262}"/>
                </a:ext>
              </a:extLst>
            </p:cNvPr>
            <p:cNvCxnSpPr>
              <a:cxnSpLocks/>
            </p:cNvCxnSpPr>
            <p:nvPr/>
          </p:nvCxnSpPr>
          <p:spPr>
            <a:xfrm>
              <a:off x="6570639" y="6223894"/>
              <a:ext cx="0" cy="634106"/>
            </a:xfrm>
            <a:prstGeom prst="line">
              <a:avLst/>
            </a:prstGeom>
            <a:ln>
              <a:solidFill>
                <a:schemeClr val="tx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EF11F27A-B6B9-BE47-8A9D-80AECDD48233}"/>
                </a:ext>
              </a:extLst>
            </p:cNvPr>
            <p:cNvSpPr txBox="1"/>
            <p:nvPr/>
          </p:nvSpPr>
          <p:spPr>
            <a:xfrm>
              <a:off x="2674352" y="6271048"/>
              <a:ext cx="161301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>
                  <a:latin typeface="Times" pitchFamily="2" charset="0"/>
                  <a:cs typeface="Times New Roman" panose="02020603050405020304" pitchFamily="18" charset="0"/>
                </a:rPr>
                <a:t>GLT component</a:t>
              </a:r>
            </a:p>
            <a:p>
              <a:r>
                <a:rPr lang="en-GB" sz="800">
                  <a:latin typeface="Times" pitchFamily="2" charset="0"/>
                  <a:cs typeface="Times New Roman" panose="02020603050405020304" pitchFamily="18" charset="0"/>
                </a:rPr>
                <a:t>Reported 2 ways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B0F1A448-28E0-C342-AF6C-98511CB6DF5A}"/>
                </a:ext>
              </a:extLst>
            </p:cNvPr>
            <p:cNvSpPr txBox="1"/>
            <p:nvPr/>
          </p:nvSpPr>
          <p:spPr>
            <a:xfrm>
              <a:off x="4693825" y="6271048"/>
              <a:ext cx="161301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>
                  <a:latin typeface="Times" pitchFamily="2" charset="0"/>
                  <a:cs typeface="Times New Roman" panose="02020603050405020304" pitchFamily="18" charset="0"/>
                </a:rPr>
                <a:t>Time component</a:t>
              </a:r>
            </a:p>
            <a:p>
              <a:r>
                <a:rPr lang="en-GB" sz="800">
                  <a:latin typeface="Times" pitchFamily="2" charset="0"/>
                  <a:cs typeface="Times New Roman" panose="02020603050405020304" pitchFamily="18" charset="0"/>
                </a:rPr>
                <a:t>Reported 5 ways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1CEC9ACC-B735-F647-8ACD-28FA2E1B0326}"/>
                </a:ext>
              </a:extLst>
            </p:cNvPr>
            <p:cNvSpPr txBox="1"/>
            <p:nvPr/>
          </p:nvSpPr>
          <p:spPr>
            <a:xfrm>
              <a:off x="6714917" y="6271048"/>
              <a:ext cx="161301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>
                  <a:latin typeface="Times" pitchFamily="2" charset="0"/>
                  <a:cs typeface="Times New Roman" panose="02020603050405020304" pitchFamily="18" charset="0"/>
                </a:rPr>
                <a:t>Glycaemic component</a:t>
              </a:r>
            </a:p>
            <a:p>
              <a:r>
                <a:rPr lang="en-GB" sz="800">
                  <a:latin typeface="Times" pitchFamily="2" charset="0"/>
                  <a:cs typeface="Times New Roman" panose="02020603050405020304" pitchFamily="18" charset="0"/>
                </a:rPr>
                <a:t>Reported 13 ways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4139858F-7AD7-A44C-B27A-27C22550F6F5}"/>
                </a:ext>
              </a:extLst>
            </p:cNvPr>
            <p:cNvSpPr txBox="1"/>
            <p:nvPr/>
          </p:nvSpPr>
          <p:spPr>
            <a:xfrm>
              <a:off x="2613497" y="2953695"/>
              <a:ext cx="19413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800">
                  <a:latin typeface="Times" pitchFamily="2" charset="0"/>
                </a:rPr>
                <a:t>absence of GLT specified: 61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DFA5225E-E03C-2B4C-A707-7CCAC8EC3D38}"/>
                </a:ext>
              </a:extLst>
            </p:cNvPr>
            <p:cNvSpPr txBox="1"/>
            <p:nvPr/>
          </p:nvSpPr>
          <p:spPr>
            <a:xfrm>
              <a:off x="8594122" y="565557"/>
              <a:ext cx="26379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>
                  <a:latin typeface="Times" pitchFamily="2" charset="0"/>
                </a:rPr>
                <a:t>HbA1c &lt;48mmol/mol, FPG &lt;5.6mmol/l :1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D3D3C63E-7A15-B14A-9A69-A1B5343E29A6}"/>
                </a:ext>
              </a:extLst>
            </p:cNvPr>
            <p:cNvSpPr txBox="1"/>
            <p:nvPr/>
          </p:nvSpPr>
          <p:spPr>
            <a:xfrm>
              <a:off x="8593953" y="2921982"/>
              <a:ext cx="28242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>
                  <a:latin typeface="Times" pitchFamily="2" charset="0"/>
                </a:rPr>
                <a:t>HbA1c &lt;42mmol/mol, FPG &lt;5.6mmol/l: 5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D24766FE-BEBF-ED45-98E9-BE71E6108CA7}"/>
                </a:ext>
              </a:extLst>
            </p:cNvPr>
            <p:cNvSpPr txBox="1"/>
            <p:nvPr/>
          </p:nvSpPr>
          <p:spPr>
            <a:xfrm>
              <a:off x="8656354" y="4843128"/>
              <a:ext cx="28242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>
                  <a:latin typeface="Times" pitchFamily="2" charset="0"/>
                </a:rPr>
                <a:t>HbA1c &lt;42mmol/mol or FPG &lt;5.6mmol/l: 2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B6B42803-D142-B14B-B18E-BB44D857F8B3}"/>
                </a:ext>
              </a:extLst>
            </p:cNvPr>
            <p:cNvSpPr txBox="1"/>
            <p:nvPr/>
          </p:nvSpPr>
          <p:spPr>
            <a:xfrm>
              <a:off x="5397910" y="1179105"/>
              <a:ext cx="11727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800">
                  <a:latin typeface="Times" pitchFamily="2" charset="0"/>
                </a:rPr>
                <a:t>at 18 months: 1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633B4C47-9835-6C41-BB27-044C1C41001D}"/>
                </a:ext>
              </a:extLst>
            </p:cNvPr>
            <p:cNvSpPr txBox="1"/>
            <p:nvPr/>
          </p:nvSpPr>
          <p:spPr>
            <a:xfrm>
              <a:off x="3543700" y="5425700"/>
              <a:ext cx="10394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800">
                  <a:latin typeface="Times" pitchFamily="2" charset="0"/>
                </a:rPr>
                <a:t>Some GLT: 1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6BCCC8EA-085E-D74F-846A-4DF499FA7A05}"/>
                </a:ext>
              </a:extLst>
            </p:cNvPr>
            <p:cNvSpPr txBox="1"/>
            <p:nvPr/>
          </p:nvSpPr>
          <p:spPr>
            <a:xfrm>
              <a:off x="8594122" y="308411"/>
              <a:ext cx="28054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>
                  <a:latin typeface="Times" pitchFamily="2" charset="0"/>
                </a:rPr>
                <a:t>HbA1c&lt; 39mmol/mol or FPG &lt;5.6mmol/l: 1</a:t>
              </a:r>
            </a:p>
          </p:txBody>
        </p:sp>
      </p:grpSp>
      <p:sp>
        <p:nvSpPr>
          <p:cNvPr id="3" name="Rectangle 2">
            <a:extLst>
              <a:ext uri="{FF2B5EF4-FFF2-40B4-BE49-F238E27FC236}">
                <a16:creationId xmlns:a16="http://schemas.microsoft.com/office/drawing/2014/main" id="{2FDC7682-95A9-054B-8A5B-71D8D1CD48A1}"/>
              </a:ext>
            </a:extLst>
          </p:cNvPr>
          <p:cNvSpPr/>
          <p:nvPr/>
        </p:nvSpPr>
        <p:spPr>
          <a:xfrm>
            <a:off x="0" y="12186"/>
            <a:ext cx="12192000" cy="28020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1000"/>
              </a:spcAft>
            </a:pPr>
            <a:r>
              <a:rPr lang="en-GB" sz="1200" b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3 Fig: Sankey </a:t>
            </a: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Diagram to illustrate heterogeneity for each component of the remission definition: glucose lowering therapy, time and glycaemic component for Complete Remission</a:t>
            </a:r>
            <a:endParaRPr lang="en-GB" sz="11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A93A53AB-0E3F-2640-8D30-AD2A0AB139A6}"/>
              </a:ext>
            </a:extLst>
          </p:cNvPr>
          <p:cNvSpPr/>
          <p:nvPr/>
        </p:nvSpPr>
        <p:spPr>
          <a:xfrm>
            <a:off x="0" y="534270"/>
            <a:ext cx="4530398" cy="2566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05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ed indicates missing or ambiguous within each component only</a:t>
            </a:r>
            <a:endParaRPr lang="en-GB" sz="1050" b="1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617391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535</Words>
  <Application>Microsoft Macintosh PowerPoint</Application>
  <PresentationFormat>Widescreen</PresentationFormat>
  <Paragraphs>6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PTIEUX Rae</dc:creator>
  <cp:lastModifiedBy>CAPTIEUX Rae</cp:lastModifiedBy>
  <cp:revision>5</cp:revision>
  <dcterms:created xsi:type="dcterms:W3CDTF">2020-09-01T19:34:41Z</dcterms:created>
  <dcterms:modified xsi:type="dcterms:W3CDTF">2020-09-24T21:32:17Z</dcterms:modified>
</cp:coreProperties>
</file>